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jpeg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3B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3B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3B. </a:t>
            </a:r>
          </a:p>
        </p:txBody>
      </p:sp>
      <p:pic>
        <p:nvPicPr>
          <p:cNvPr id="13" name="Picture 12" descr="A black and white photo of a film strip&#10;&#10;Description automatically generated">
            <a:extLst>
              <a:ext uri="{FF2B5EF4-FFF2-40B4-BE49-F238E27FC236}">
                <a16:creationId xmlns:a16="http://schemas.microsoft.com/office/drawing/2014/main" id="{338E6858-F31D-4458-FC25-C44068B509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73" y="2732608"/>
            <a:ext cx="5344595" cy="4275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A90B254-CE57-4786-8434-001DC6CED1BB}">
  <ds:schemaRefs>
    <ds:schemaRef ds:uri="http://purl.org/dc/dcmitype/"/>
    <ds:schemaRef ds:uri="http://schemas.microsoft.com/office/2006/documentManagement/types"/>
    <ds:schemaRef ds:uri="http://www.w3.org/XML/1998/namespace"/>
    <ds:schemaRef ds:uri="1ada6c1b-6627-4503-b0bd-5fd9b9908e29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18272914-71e0-42fc-9685-7c3d7493b947"/>
    <ds:schemaRef ds:uri="http://schemas.microsoft.com/office/2006/metadata/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35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2</cp:revision>
  <cp:lastPrinted>2025-01-06T21:11:05Z</cp:lastPrinted>
  <dcterms:created xsi:type="dcterms:W3CDTF">2020-01-28T22:13:46Z</dcterms:created>
  <dcterms:modified xsi:type="dcterms:W3CDTF">2025-01-07T18:57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